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4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LAUSSEN Ken" initials="OK" lastIdx="9" clrIdx="0">
    <p:extLst>
      <p:ext uri="{19B8F6BF-5375-455C-9EA6-DF929625EA0E}">
        <p15:presenceInfo xmlns:p15="http://schemas.microsoft.com/office/powerpoint/2012/main" userId="S::Ken.OLAUSSEN@gustaveroussy.fr::b52c742c-e89a-44fb-b980-43c65ab3f22f" providerId="AD"/>
      </p:ext>
    </p:extLst>
  </p:cmAuthor>
  <p:cmAuthor id="2" name="FRIBOULET Luc" initials="FL" lastIdx="14" clrIdx="1">
    <p:extLst>
      <p:ext uri="{19B8F6BF-5375-455C-9EA6-DF929625EA0E}">
        <p15:presenceInfo xmlns:p15="http://schemas.microsoft.com/office/powerpoint/2012/main" userId="S::Luc.FRIBOULET@gustaveroussy.fr::24e6c35a-934b-461c-8797-c45cd64d339c" providerId="AD"/>
      </p:ext>
    </p:extLst>
  </p:cmAuthor>
  <p:cmAuthor id="3" name="Francesco Facchinetti" initials="FF" lastIdx="7" clrIdx="2">
    <p:extLst>
      <p:ext uri="{19B8F6BF-5375-455C-9EA6-DF929625EA0E}">
        <p15:presenceInfo xmlns:p15="http://schemas.microsoft.com/office/powerpoint/2012/main" userId="f3dc93800fbbcdac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essuno stile, nessuna grigli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4843"/>
    <p:restoredTop sz="96076"/>
  </p:normalViewPr>
  <p:slideViewPr>
    <p:cSldViewPr snapToGrid="0">
      <p:cViewPr varScale="1">
        <p:scale>
          <a:sx n="81" d="100"/>
          <a:sy n="81" d="100"/>
        </p:scale>
        <p:origin x="200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17D927-84AB-D343-A8FA-D1DF57CB95F5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7D9D5EC-21A0-0C4D-9161-B263BFB5BFB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783713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494071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644771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896505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591863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334090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378945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979706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245421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618666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433844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325213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283304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au 14">
            <a:extLst>
              <a:ext uri="{FF2B5EF4-FFF2-40B4-BE49-F238E27FC236}">
                <a16:creationId xmlns:a16="http://schemas.microsoft.com/office/drawing/2014/main" id="{75EBE914-694A-DCDF-5E9C-E2DE514067DB}"/>
              </a:ext>
            </a:extLst>
          </p:cNvPr>
          <p:cNvGraphicFramePr>
            <a:graphicFrameLocks noGrp="1"/>
          </p:cNvGraphicFramePr>
          <p:nvPr/>
        </p:nvGraphicFramePr>
        <p:xfrm>
          <a:off x="260131" y="555334"/>
          <a:ext cx="3358055" cy="436814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388476">
                  <a:extLst>
                    <a:ext uri="{9D8B030D-6E8A-4147-A177-3AD203B41FA5}">
                      <a16:colId xmlns:a16="http://schemas.microsoft.com/office/drawing/2014/main" val="3248908959"/>
                    </a:ext>
                  </a:extLst>
                </a:gridCol>
                <a:gridCol w="969579">
                  <a:extLst>
                    <a:ext uri="{9D8B030D-6E8A-4147-A177-3AD203B41FA5}">
                      <a16:colId xmlns:a16="http://schemas.microsoft.com/office/drawing/2014/main" val="3822663905"/>
                    </a:ext>
                  </a:extLst>
                </a:gridCol>
              </a:tblGrid>
              <a:tr h="171360">
                <a:tc>
                  <a:txBody>
                    <a:bodyPr/>
                    <a:lstStyle/>
                    <a:p>
                      <a:pPr algn="ctr"/>
                      <a:r>
                        <a:rPr lang="fr-FR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= 36</a:t>
                      </a:r>
                    </a:p>
                  </a:txBody>
                  <a:tcPr marL="62345" marR="62345" marT="31173" marB="31173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(%)</a:t>
                      </a:r>
                      <a:endParaRPr lang="fr-FR" sz="8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345" marR="62345" marT="31173" marB="3117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81545061"/>
                  </a:ext>
                </a:extLst>
              </a:tr>
              <a:tr h="166255">
                <a:tc>
                  <a:txBody>
                    <a:bodyPr/>
                    <a:lstStyle/>
                    <a:p>
                      <a:r>
                        <a:rPr lang="fr-FR" sz="8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mor</a:t>
                      </a:r>
                      <a:r>
                        <a:rPr lang="fr-FR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8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stology</a:t>
                      </a:r>
                      <a:endParaRPr lang="fr-FR" sz="8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345" marR="62345" marT="31173" marB="31173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345" marR="62345" marT="31173" marB="3117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7172967"/>
                  </a:ext>
                </a:extLst>
              </a:tr>
              <a:tr h="166255">
                <a:tc>
                  <a:txBody>
                    <a:bodyPr/>
                    <a:lstStyle/>
                    <a:p>
                      <a:r>
                        <a:rPr lang="fr-FR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rahepatic</a:t>
                      </a:r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olangiocarcinoma</a:t>
                      </a:r>
                      <a:endParaRPr lang="fr-FR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345" marR="62345" marT="31173" marB="31173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 (75)</a:t>
                      </a:r>
                    </a:p>
                  </a:txBody>
                  <a:tcPr marL="62345" marR="62345" marT="31173" marB="3117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6804136"/>
                  </a:ext>
                </a:extLst>
              </a:tr>
              <a:tr h="166255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her</a:t>
                      </a:r>
                      <a:r>
                        <a:rPr lang="fr-FR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8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mor</a:t>
                      </a:r>
                      <a:r>
                        <a:rPr lang="fr-FR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ypes</a:t>
                      </a:r>
                      <a:endParaRPr lang="fr-FR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345" marR="62345" marT="31173" marB="31173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 (25)</a:t>
                      </a:r>
                    </a:p>
                  </a:txBody>
                  <a:tcPr marL="62345" marR="62345" marT="31173" marB="3117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68557749"/>
                  </a:ext>
                </a:extLst>
              </a:tr>
              <a:tr h="166255">
                <a:tc>
                  <a:txBody>
                    <a:bodyPr/>
                    <a:lstStyle/>
                    <a:p>
                      <a:r>
                        <a:rPr lang="fr-FR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iver</a:t>
                      </a:r>
                    </a:p>
                  </a:txBody>
                  <a:tcPr marL="62345" marR="62345" marT="31173" marB="31173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345" marR="62345" marT="31173" marB="3117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4101000"/>
                  </a:ext>
                </a:extLst>
              </a:tr>
              <a:tr h="175310">
                <a:tc>
                  <a:txBody>
                    <a:bodyPr/>
                    <a:lstStyle/>
                    <a:p>
                      <a:r>
                        <a:rPr lang="fr-FR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R2</a:t>
                      </a:r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fusion</a:t>
                      </a:r>
                    </a:p>
                  </a:txBody>
                  <a:tcPr marL="62345" marR="62345" marT="31173" marB="31173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 (86)</a:t>
                      </a:r>
                    </a:p>
                  </a:txBody>
                  <a:tcPr marL="62345" marR="62345" marT="31173" marB="3117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80202776"/>
                  </a:ext>
                </a:extLst>
              </a:tr>
              <a:tr h="171987">
                <a:tc>
                  <a:txBody>
                    <a:bodyPr/>
                    <a:lstStyle/>
                    <a:p>
                      <a:r>
                        <a:rPr lang="fr-FR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R2 </a:t>
                      </a:r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tations</a:t>
                      </a:r>
                    </a:p>
                  </a:txBody>
                  <a:tcPr marL="62345" marR="62345" marT="31173" marB="31173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14)</a:t>
                      </a:r>
                    </a:p>
                  </a:txBody>
                  <a:tcPr marL="62345" marR="62345" marT="31173" marB="3117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69514794"/>
                  </a:ext>
                </a:extLst>
              </a:tr>
              <a:tr h="177721">
                <a:tc>
                  <a:txBody>
                    <a:bodyPr/>
                    <a:lstStyle/>
                    <a:p>
                      <a:r>
                        <a:rPr lang="fr-FR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rst FGFR </a:t>
                      </a:r>
                      <a:r>
                        <a:rPr lang="fr-FR" sz="800" b="1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hibitor</a:t>
                      </a:r>
                      <a:r>
                        <a:rPr lang="fr-FR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800" b="1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ceived</a:t>
                      </a:r>
                      <a:endParaRPr lang="fr-FR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0655" marR="50655" marT="25328" marB="253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0900703"/>
                  </a:ext>
                </a:extLst>
              </a:tr>
              <a:tr h="182737">
                <a:tc>
                  <a:txBody>
                    <a:bodyPr/>
                    <a:lstStyle/>
                    <a:p>
                      <a:r>
                        <a:rPr lang="fr-FR" sz="800" b="1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ible</a:t>
                      </a:r>
                      <a:r>
                        <a:rPr lang="fr-FR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800" b="1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hibitors</a:t>
                      </a:r>
                      <a:endParaRPr lang="fr-FR" sz="800" b="1" i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b="0" i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 (64)</a:t>
                      </a:r>
                    </a:p>
                  </a:txBody>
                  <a:tcPr marL="50655" marR="50655" marT="25328" marB="253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61073323"/>
                  </a:ext>
                </a:extLst>
              </a:tr>
              <a:tr h="204235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</a:t>
                      </a:r>
                      <a:r>
                        <a:rPr lang="fr-FR" sz="800" b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rahepatic</a:t>
                      </a:r>
                      <a:r>
                        <a:rPr lang="fr-FR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800" b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olangiocarcinoma</a:t>
                      </a:r>
                      <a:r>
                        <a:rPr lang="fr-FR" sz="800" b="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 (50)</a:t>
                      </a:r>
                    </a:p>
                  </a:txBody>
                  <a:tcPr marL="50655" marR="50655" marT="25328" marB="253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2416811"/>
                  </a:ext>
                </a:extLst>
              </a:tr>
              <a:tr h="214984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</a:t>
                      </a:r>
                      <a:r>
                        <a:rPr lang="fr-FR" sz="800" b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her</a:t>
                      </a:r>
                      <a:r>
                        <a:rPr lang="fr-FR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800" b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mor</a:t>
                      </a:r>
                      <a:r>
                        <a:rPr lang="fr-FR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ypes</a:t>
                      </a:r>
                      <a:endParaRPr lang="fr-FR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14)</a:t>
                      </a:r>
                    </a:p>
                  </a:txBody>
                  <a:tcPr marL="50655" marR="50655" marT="25328" marB="253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34664742"/>
                  </a:ext>
                </a:extLst>
              </a:tr>
              <a:tr h="204235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tibatinib</a:t>
                      </a:r>
                      <a:endParaRPr lang="fr-FR" sz="800" b="1" i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 (36)</a:t>
                      </a:r>
                      <a:endParaRPr lang="fr-FR" sz="800" b="0" i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0655" marR="50655" marT="25328" marB="253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29894566"/>
                  </a:ext>
                </a:extLst>
              </a:tr>
              <a:tr h="214984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</a:t>
                      </a:r>
                      <a:r>
                        <a:rPr lang="fr-FR" sz="800" b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rahepatic</a:t>
                      </a:r>
                      <a:r>
                        <a:rPr lang="fr-FR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800" b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olangiocarcinoma</a:t>
                      </a:r>
                      <a:r>
                        <a:rPr lang="fr-FR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 (25)</a:t>
                      </a:r>
                    </a:p>
                  </a:txBody>
                  <a:tcPr marL="50655" marR="50655" marT="25328" marB="253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25641081"/>
                  </a:ext>
                </a:extLst>
              </a:tr>
              <a:tr h="214984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</a:t>
                      </a:r>
                      <a:r>
                        <a:rPr lang="fr-FR" sz="800" b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her</a:t>
                      </a:r>
                      <a:r>
                        <a:rPr lang="fr-FR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800" b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mor</a:t>
                      </a:r>
                      <a:r>
                        <a:rPr lang="fr-FR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ypes</a:t>
                      </a:r>
                      <a:endParaRPr lang="fr-FR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11)</a:t>
                      </a:r>
                    </a:p>
                  </a:txBody>
                  <a:tcPr marL="50655" marR="50655" marT="25328" marB="253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86298710"/>
                  </a:ext>
                </a:extLst>
              </a:tr>
              <a:tr h="171987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1" u="none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eatment</a:t>
                      </a:r>
                      <a:r>
                        <a:rPr lang="fr-FR" sz="800" b="1" u="none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800" b="1" u="none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ne </a:t>
                      </a:r>
                      <a:r>
                        <a:rPr lang="fr-FR" sz="800" b="1" u="none" baseline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  <a:r>
                        <a:rPr lang="fr-FR" sz="800" b="1" u="none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range)</a:t>
                      </a:r>
                      <a:endParaRPr lang="fr-FR" sz="800" b="1" u="none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fr-FR" sz="800" b="0" u="none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0655" marR="50655" marT="25328" marB="253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95064842"/>
                  </a:ext>
                </a:extLst>
              </a:tr>
              <a:tr h="166255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0" u="none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</a:t>
                      </a:r>
                      <a:r>
                        <a:rPr lang="fr-FR" sz="800" b="0" u="none" baseline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rahepatic</a:t>
                      </a:r>
                      <a:r>
                        <a:rPr lang="fr-FR" sz="800" b="0" u="none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800" b="0" u="none" baseline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olangiocarcinoma</a:t>
                      </a:r>
                      <a:endParaRPr lang="fr-FR" sz="800" b="0" i="0" u="none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0655" marR="50655" marT="25328" marB="253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2-7)</a:t>
                      </a:r>
                    </a:p>
                  </a:txBody>
                  <a:tcPr marL="50655" marR="50655" marT="25328" marB="253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0444719"/>
                  </a:ext>
                </a:extLst>
              </a:tr>
              <a:tr h="166255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0" u="none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 </a:t>
                      </a:r>
                      <a:r>
                        <a:rPr lang="fr-FR" sz="800" b="0" u="none" baseline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her</a:t>
                      </a:r>
                      <a:r>
                        <a:rPr lang="fr-FR" sz="800" b="0" u="none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800" b="0" u="none" baseline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mor</a:t>
                      </a:r>
                      <a:r>
                        <a:rPr lang="fr-FR" sz="800" b="0" u="none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ypes</a:t>
                      </a:r>
                      <a:endParaRPr lang="fr-FR" sz="800" b="0" i="0" u="none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0" u="none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2-9)</a:t>
                      </a:r>
                    </a:p>
                  </a:txBody>
                  <a:tcPr marL="50655" marR="50655" marT="25328" marB="253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5037583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fr-FR" sz="100" b="0" i="0" u="none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fr-FR" sz="100" b="0" u="none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0655" marR="50655" marT="25328" marB="253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79872522"/>
                  </a:ext>
                </a:extLst>
              </a:tr>
              <a:tr h="178437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1" i="0" u="none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tial</a:t>
                      </a:r>
                      <a:r>
                        <a:rPr lang="fr-FR" sz="800" b="1" i="0" u="none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800" b="1" i="0" u="none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lecular</a:t>
                      </a:r>
                      <a:r>
                        <a:rPr lang="fr-FR" sz="800" b="1" i="0" u="none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800" b="1" i="0" u="none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eatments</a:t>
                      </a:r>
                      <a:endParaRPr lang="fr-FR" sz="800" b="1" i="0" u="none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0" u="none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 (33)</a:t>
                      </a:r>
                    </a:p>
                  </a:txBody>
                  <a:tcPr marL="50655" marR="50655" marT="25328" marB="253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4409632"/>
                  </a:ext>
                </a:extLst>
              </a:tr>
              <a:tr h="178437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0" i="0" u="none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ible</a:t>
                      </a:r>
                      <a:r>
                        <a:rPr lang="fr-FR" sz="800" b="0" i="0" u="none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800" b="0" i="0" u="none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hibitor</a:t>
                      </a:r>
                      <a:r>
                        <a:rPr lang="fr-FR" sz="800" b="0" i="0" u="none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800" b="0" i="0" u="none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Wingdings" pitchFamily="2" charset="2"/>
                        </a:rPr>
                        <a:t> </a:t>
                      </a:r>
                      <a:r>
                        <a:rPr lang="fr-FR" sz="800" b="0" i="0" u="none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Wingdings" pitchFamily="2" charset="2"/>
                        </a:rPr>
                        <a:t>everolimus</a:t>
                      </a:r>
                      <a:r>
                        <a:rPr lang="fr-FR" sz="800" b="0" i="0" u="none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Wingdings" pitchFamily="2" charset="2"/>
                        </a:rPr>
                        <a:t>  </a:t>
                      </a:r>
                      <a:r>
                        <a:rPr lang="fr-FR" sz="800" b="0" i="0" u="none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Wingdings" pitchFamily="2" charset="2"/>
                        </a:rPr>
                        <a:t>futibatinib</a:t>
                      </a:r>
                      <a:r>
                        <a:rPr lang="fr-FR" sz="800" b="0" i="0" u="none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Wingdings" pitchFamily="2" charset="2"/>
                        </a:rPr>
                        <a:t> </a:t>
                      </a:r>
                      <a:endParaRPr lang="fr-FR" sz="800" b="0" i="0" u="none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0" u="none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50655" marR="50655" marT="25328" marB="253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10628804"/>
                  </a:ext>
                </a:extLst>
              </a:tr>
              <a:tr h="178437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0" i="0" u="none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ible</a:t>
                      </a:r>
                      <a:r>
                        <a:rPr lang="fr-FR" sz="800" b="0" i="0" u="none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800" b="0" i="0" u="none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hibitor</a:t>
                      </a:r>
                      <a:r>
                        <a:rPr lang="fr-FR" sz="800" b="0" i="0" u="none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800" b="0" i="0" u="none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Wingdings" pitchFamily="2" charset="2"/>
                        </a:rPr>
                        <a:t> </a:t>
                      </a:r>
                      <a:r>
                        <a:rPr lang="fr-FR" sz="800" b="0" i="0" u="none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Wingdings" pitchFamily="2" charset="2"/>
                        </a:rPr>
                        <a:t>futibatinib</a:t>
                      </a:r>
                      <a:r>
                        <a:rPr lang="fr-FR" sz="800" b="0" i="0" u="none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Wingdings" pitchFamily="2" charset="2"/>
                        </a:rPr>
                        <a:t>  </a:t>
                      </a:r>
                      <a:r>
                        <a:rPr lang="fr-FR" sz="800" b="0" i="0" u="none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Wingdings" pitchFamily="2" charset="2"/>
                        </a:rPr>
                        <a:t>everolimus</a:t>
                      </a:r>
                      <a:r>
                        <a:rPr lang="fr-FR" sz="800" b="0" i="0" u="none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Wingdings" pitchFamily="2" charset="2"/>
                        </a:rPr>
                        <a:t> </a:t>
                      </a:r>
                      <a:endParaRPr lang="fr-FR" sz="800" b="0" i="0" u="none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0" u="none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50655" marR="50655" marT="25328" marB="253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7488030"/>
                  </a:ext>
                </a:extLst>
              </a:tr>
              <a:tr h="178437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0" i="0" u="none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ible</a:t>
                      </a:r>
                      <a:r>
                        <a:rPr lang="fr-FR" sz="800" b="0" i="0" u="none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800" b="0" i="0" u="none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hibitor</a:t>
                      </a:r>
                      <a:r>
                        <a:rPr lang="fr-FR" sz="800" b="0" i="0" u="none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800" b="0" i="0" u="none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Wingdings" pitchFamily="2" charset="2"/>
                        </a:rPr>
                        <a:t> </a:t>
                      </a:r>
                      <a:r>
                        <a:rPr lang="fr-FR" sz="800" b="0" i="0" u="none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Wingdings" pitchFamily="2" charset="2"/>
                        </a:rPr>
                        <a:t>futibatinib</a:t>
                      </a:r>
                      <a:r>
                        <a:rPr lang="fr-FR" sz="800" b="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</a:t>
                      </a:r>
                      <a:endParaRPr lang="fr-FR" sz="800" b="0" i="0" u="none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0" u="none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50655" marR="50655" marT="25328" marB="253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11178103"/>
                  </a:ext>
                </a:extLst>
              </a:tr>
              <a:tr h="178437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0" i="0" u="none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ible</a:t>
                      </a:r>
                      <a:r>
                        <a:rPr lang="fr-FR" sz="800" b="0" i="0" u="none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800" b="0" i="0" u="none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hibitor</a:t>
                      </a:r>
                      <a:r>
                        <a:rPr lang="fr-FR" sz="800" b="0" i="0" u="none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800" b="0" i="0" u="none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Wingdings" pitchFamily="2" charset="2"/>
                        </a:rPr>
                        <a:t> </a:t>
                      </a:r>
                      <a:r>
                        <a:rPr lang="fr-FR" sz="800" b="0" i="0" u="none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Wingdings" pitchFamily="2" charset="2"/>
                        </a:rPr>
                        <a:t>lirafugratinib</a:t>
                      </a:r>
                      <a:endParaRPr lang="fr-FR" sz="800" b="0" i="0" u="none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0" u="none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50655" marR="50655" marT="25328" marB="253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99955740"/>
                  </a:ext>
                </a:extLst>
              </a:tr>
              <a:tr h="178437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0" i="0" u="none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tibatinib</a:t>
                      </a:r>
                      <a:r>
                        <a:rPr lang="fr-FR" sz="800" b="0" i="0" u="none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800" b="0" i="0" u="none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Wingdings" pitchFamily="2" charset="2"/>
                        </a:rPr>
                        <a:t> </a:t>
                      </a:r>
                      <a:r>
                        <a:rPr lang="fr-FR" sz="800" b="0" i="0" u="none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  <a:sym typeface="Wingdings" pitchFamily="2" charset="2"/>
                        </a:rPr>
                        <a:t>lirafugratinib</a:t>
                      </a:r>
                      <a:endParaRPr lang="fr-FR" sz="800" b="0" i="0" u="none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0" u="none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50655" marR="50655" marT="25328" marB="253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29329846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44399D4C-7054-94C1-A8F0-F1D63FF52F94}"/>
              </a:ext>
            </a:extLst>
          </p:cNvPr>
          <p:cNvSpPr txBox="1"/>
          <p:nvPr/>
        </p:nvSpPr>
        <p:spPr>
          <a:xfrm>
            <a:off x="224658" y="4986638"/>
            <a:ext cx="3429000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fr-FR" sz="8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fr-FR" sz="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able S1. Baseline </a:t>
            </a:r>
            <a:r>
              <a:rPr lang="fr-FR" sz="8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aracteristics</a:t>
            </a:r>
            <a:r>
              <a:rPr lang="fr-FR" sz="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of patients </a:t>
            </a:r>
            <a:r>
              <a:rPr lang="fr-FR" sz="8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cluded</a:t>
            </a:r>
            <a:r>
              <a:rPr lang="fr-FR" sz="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 the </a:t>
            </a:r>
            <a:r>
              <a:rPr lang="fr-FR" sz="8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udy</a:t>
            </a:r>
            <a:r>
              <a:rPr lang="fr-FR" sz="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fr-FR" sz="8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eatment</a:t>
            </a:r>
            <a:r>
              <a:rPr lang="fr-FR" sz="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fr-FR" sz="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lective</a:t>
            </a:r>
            <a:r>
              <a:rPr lang="fr-FR" sz="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FGFR </a:t>
            </a:r>
            <a:r>
              <a:rPr lang="fr-FR" sz="8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hibitors</a:t>
            </a:r>
            <a:r>
              <a:rPr lang="fr-FR" sz="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fr-FR" sz="1200" b="0" baseline="30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fr-FR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fr-FR" sz="1000" b="0" baseline="3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r>
              <a:rPr lang="fr-FR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b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 </a:t>
            </a:r>
            <a:r>
              <a:rPr lang="fr-FR" sz="800" b="1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1748</a:t>
            </a:r>
            <a:r>
              <a:rPr lang="fr-FR" sz="800" b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b="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ceive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futibatinib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after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progessing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on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zoligratinib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but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resistance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was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assessed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only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at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futibatinib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progression (not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included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in Figure 1).</a:t>
            </a:r>
            <a:endParaRPr lang="en-US" sz="800" dirty="0"/>
          </a:p>
        </p:txBody>
      </p:sp>
    </p:spTree>
    <p:extLst>
      <p:ext uri="{BB962C8B-B14F-4D97-AF65-F5344CB8AC3E}">
        <p14:creationId xmlns:p14="http://schemas.microsoft.com/office/powerpoint/2010/main" val="354014216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62180</TotalTime>
  <Words>179</Words>
  <Application>Microsoft Macintosh PowerPoint</Application>
  <PresentationFormat>A4 (21x29,7 cm)</PresentationFormat>
  <Paragraphs>45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rancesco Facchinetti</dc:creator>
  <cp:lastModifiedBy>Francesco Facchinetti</cp:lastModifiedBy>
  <cp:revision>143</cp:revision>
  <dcterms:created xsi:type="dcterms:W3CDTF">2022-09-21T18:46:54Z</dcterms:created>
  <dcterms:modified xsi:type="dcterms:W3CDTF">2024-06-11T15:09:35Z</dcterms:modified>
</cp:coreProperties>
</file>